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AUSSEN Ken" initials="OK" lastIdx="9" clrIdx="0">
    <p:extLst>
      <p:ext uri="{19B8F6BF-5375-455C-9EA6-DF929625EA0E}">
        <p15:presenceInfo xmlns:p15="http://schemas.microsoft.com/office/powerpoint/2012/main" userId="S::Ken.OLAUSSEN@gustaveroussy.fr::b52c742c-e89a-44fb-b980-43c65ab3f22f" providerId="AD"/>
      </p:ext>
    </p:extLst>
  </p:cmAuthor>
  <p:cmAuthor id="2" name="FRIBOULET Luc" initials="FL" lastIdx="14" clrIdx="1">
    <p:extLst>
      <p:ext uri="{19B8F6BF-5375-455C-9EA6-DF929625EA0E}">
        <p15:presenceInfo xmlns:p15="http://schemas.microsoft.com/office/powerpoint/2012/main" userId="S::Luc.FRIBOULET@gustaveroussy.fr::24e6c35a-934b-461c-8797-c45cd64d339c" providerId="AD"/>
      </p:ext>
    </p:extLst>
  </p:cmAuthor>
  <p:cmAuthor id="3" name="Francesco Facchinetti" initials="FF" lastIdx="7" clrIdx="2">
    <p:extLst>
      <p:ext uri="{19B8F6BF-5375-455C-9EA6-DF929625EA0E}">
        <p15:presenceInfo xmlns:p15="http://schemas.microsoft.com/office/powerpoint/2012/main" userId="f3dc93800fbbcd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843"/>
    <p:restoredTop sz="96076"/>
  </p:normalViewPr>
  <p:slideViewPr>
    <p:cSldViewPr snapToGrid="0">
      <p:cViewPr varScale="1">
        <p:scale>
          <a:sx n="81" d="100"/>
          <a:sy n="81" d="100"/>
        </p:scale>
        <p:origin x="200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17D927-84AB-D343-A8FA-D1DF57CB95F5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9D5EC-21A0-0C4D-9161-B263BFB5B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371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4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447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965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918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40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789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97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54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186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38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2521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0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9970C9F8-1322-CCDF-A177-81C84BF026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9677034"/>
              </p:ext>
            </p:extLst>
          </p:nvPr>
        </p:nvGraphicFramePr>
        <p:xfrm>
          <a:off x="780659" y="542565"/>
          <a:ext cx="1376111" cy="4168299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49492">
                  <a:extLst>
                    <a:ext uri="{9D8B030D-6E8A-4147-A177-3AD203B41FA5}">
                      <a16:colId xmlns:a16="http://schemas.microsoft.com/office/drawing/2014/main" val="1252847888"/>
                    </a:ext>
                  </a:extLst>
                </a:gridCol>
                <a:gridCol w="726619">
                  <a:extLst>
                    <a:ext uri="{9D8B030D-6E8A-4147-A177-3AD203B41FA5}">
                      <a16:colId xmlns:a16="http://schemas.microsoft.com/office/drawing/2014/main" val="956012239"/>
                    </a:ext>
                  </a:extLst>
                </a:gridCol>
              </a:tblGrid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s</a:t>
                      </a:r>
                      <a:r>
                        <a:rPr lang="it-IT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ith </a:t>
                      </a: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CA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 driver</a:t>
                      </a: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2175334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91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BICC1</a:t>
                      </a: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1959494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332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it-IT" sz="800" u="none" strike="noStrike">
                          <a:effectLst/>
                        </a:rPr>
                        <a:t>FGFR2::BICC1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17" marR="7617" marT="76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3077785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379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it-IT" sz="800" u="none" strike="noStrike" dirty="0">
                          <a:effectLst/>
                        </a:rPr>
                        <a:t>FGFR2::BICC1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17" marR="7617" marT="76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8991353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1748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it-IT" sz="800" u="none" strike="noStrike">
                          <a:effectLst/>
                        </a:rPr>
                        <a:t>FGFR2::BICC1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17" marR="7617" marT="76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7684545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3470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it-IT" sz="800" u="none" strike="noStrike" dirty="0">
                          <a:effectLst/>
                        </a:rPr>
                        <a:t>FGFR2::BICC1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17" marR="7617" marT="76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1346708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313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STRN4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8800613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4037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CCSER2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2272619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05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CCAR1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6912289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369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INA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0377010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408 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WDHD1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3138009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488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PAWR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6112353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422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PXN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1935978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548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EVI5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4472749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553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ERC1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4846611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586 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GFR2::DIP2C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0866490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602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MITF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3217604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646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TACC2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123646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664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CIT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3559751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701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ZMYM4</a:t>
                      </a:r>
                      <a:endParaRPr lang="it-IT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2885426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719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SORBS2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6776805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822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GFR2::WAC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5138563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847 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GFR2::PHC1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419830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4131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CBX5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6531633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4455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MACF1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9410165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174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 C383R</a:t>
                      </a: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1321107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520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it-IT" sz="800" u="none" strike="noStrike" dirty="0">
                          <a:effectLst/>
                        </a:rPr>
                        <a:t>FGFR2 C383R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17" marR="7617" marT="76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4744345"/>
                  </a:ext>
                </a:extLst>
              </a:tr>
              <a:tr h="14625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620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 Y376C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89" marR="6189" marT="6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0476911"/>
                  </a:ext>
                </a:extLst>
              </a:tr>
            </a:tbl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E8DAED69-830F-4352-A8D0-8C53A35778A4}"/>
              </a:ext>
            </a:extLst>
          </p:cNvPr>
          <p:cNvSpPr txBox="1"/>
          <p:nvPr/>
        </p:nvSpPr>
        <p:spPr>
          <a:xfrm>
            <a:off x="654290" y="4831813"/>
            <a:ext cx="58989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S2.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i="1" dirty="0">
                <a:latin typeface="Arial" panose="020B0604020202020204" pitchFamily="34" charset="0"/>
                <a:cs typeface="Arial" panose="020B0604020202020204" pitchFamily="34" charset="0"/>
              </a:rPr>
              <a:t>FGFR2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drivers  of the 27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ffering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rom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4744262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2180</TotalTime>
  <Words>115</Words>
  <Application>Microsoft Macintosh PowerPoint</Application>
  <PresentationFormat>A4 (21x29,7 cm)</PresentationFormat>
  <Paragraphs>5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143</cp:revision>
  <dcterms:created xsi:type="dcterms:W3CDTF">2022-09-21T18:46:54Z</dcterms:created>
  <dcterms:modified xsi:type="dcterms:W3CDTF">2024-06-11T15:10:04Z</dcterms:modified>
</cp:coreProperties>
</file>